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088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FFF38-FD4B-4472-9068-6CFF7A98A559}" type="datetimeFigureOut">
              <a:rPr lang="fr-FR" smtClean="0"/>
              <a:pPr/>
              <a:t>20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1851F-759B-483F-97E7-8D3A0B5F083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FFF38-FD4B-4472-9068-6CFF7A98A559}" type="datetimeFigureOut">
              <a:rPr lang="fr-FR" smtClean="0"/>
              <a:pPr/>
              <a:t>20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1851F-759B-483F-97E7-8D3A0B5F083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FFF38-FD4B-4472-9068-6CFF7A98A559}" type="datetimeFigureOut">
              <a:rPr lang="fr-FR" smtClean="0"/>
              <a:pPr/>
              <a:t>20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1851F-759B-483F-97E7-8D3A0B5F083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FFF38-FD4B-4472-9068-6CFF7A98A559}" type="datetimeFigureOut">
              <a:rPr lang="fr-FR" smtClean="0"/>
              <a:pPr/>
              <a:t>20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1851F-759B-483F-97E7-8D3A0B5F083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FFF38-FD4B-4472-9068-6CFF7A98A559}" type="datetimeFigureOut">
              <a:rPr lang="fr-FR" smtClean="0"/>
              <a:pPr/>
              <a:t>20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1851F-759B-483F-97E7-8D3A0B5F083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FFF38-FD4B-4472-9068-6CFF7A98A559}" type="datetimeFigureOut">
              <a:rPr lang="fr-FR" smtClean="0"/>
              <a:pPr/>
              <a:t>20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1851F-759B-483F-97E7-8D3A0B5F083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FFF38-FD4B-4472-9068-6CFF7A98A559}" type="datetimeFigureOut">
              <a:rPr lang="fr-FR" smtClean="0"/>
              <a:pPr/>
              <a:t>20/07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1851F-759B-483F-97E7-8D3A0B5F083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FFF38-FD4B-4472-9068-6CFF7A98A559}" type="datetimeFigureOut">
              <a:rPr lang="fr-FR" smtClean="0"/>
              <a:pPr/>
              <a:t>20/07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1851F-759B-483F-97E7-8D3A0B5F083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FFF38-FD4B-4472-9068-6CFF7A98A559}" type="datetimeFigureOut">
              <a:rPr lang="fr-FR" smtClean="0"/>
              <a:pPr/>
              <a:t>20/07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1851F-759B-483F-97E7-8D3A0B5F083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FFF38-FD4B-4472-9068-6CFF7A98A559}" type="datetimeFigureOut">
              <a:rPr lang="fr-FR" smtClean="0"/>
              <a:pPr/>
              <a:t>20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1851F-759B-483F-97E7-8D3A0B5F083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FFF38-FD4B-4472-9068-6CFF7A98A559}" type="datetimeFigureOut">
              <a:rPr lang="fr-FR" smtClean="0"/>
              <a:pPr/>
              <a:t>20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1851F-759B-483F-97E7-8D3A0B5F083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2FFF38-FD4B-4472-9068-6CFF7A98A559}" type="datetimeFigureOut">
              <a:rPr lang="fr-FR" smtClean="0"/>
              <a:pPr/>
              <a:t>20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1851F-759B-483F-97E7-8D3A0B5F083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89000" y="232936"/>
            <a:ext cx="6480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fr-FR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fr-FR" sz="1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a Under the ROC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rv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UC) for the 11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ongest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atur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ociated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the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nic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dose contamination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tural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ranium. For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atur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uted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the discrimination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ose of contamination and the control group (Dose B: 0.015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g.L</a:t>
            </a:r>
            <a:r>
              <a:rPr lang="fr-FR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Dose C: 0.15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g.L</a:t>
            </a:r>
            <a:r>
              <a:rPr lang="fr-FR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Dose D: 1.5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g.L</a:t>
            </a:r>
            <a:r>
              <a:rPr lang="fr-FR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Dose E: 40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g.L</a:t>
            </a:r>
            <a:r>
              <a:rPr lang="fr-FR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)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au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9762548"/>
              </p:ext>
            </p:extLst>
          </p:nvPr>
        </p:nvGraphicFramePr>
        <p:xfrm>
          <a:off x="2132856" y="1187624"/>
          <a:ext cx="2895034" cy="4320000"/>
        </p:xfrm>
        <a:graphic>
          <a:graphicData uri="http://schemas.openxmlformats.org/drawingml/2006/table">
            <a:tbl>
              <a:tblPr/>
              <a:tblGrid>
                <a:gridCol w="770777"/>
                <a:gridCol w="531064"/>
                <a:gridCol w="531064"/>
                <a:gridCol w="539002"/>
                <a:gridCol w="523127"/>
              </a:tblGrid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Features</a:t>
                      </a:r>
                      <a:endParaRPr lang="fr-FR" sz="1100" dirty="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A vs B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A vs C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A vs D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A </a:t>
                      </a:r>
                      <a:r>
                        <a:rPr lang="en-US" sz="1100" dirty="0" err="1"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vs</a:t>
                      </a:r>
                      <a:r>
                        <a:rPr lang="en-US" sz="1100" dirty="0"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E</a:t>
                      </a:r>
                      <a:endParaRPr lang="fr-FR" sz="1100" dirty="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107T177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2.8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79.3</a:t>
                      </a:r>
                      <a:endParaRPr lang="fr-FR" sz="1100" dirty="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8.1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81.0</a:t>
                      </a:r>
                      <a:endParaRPr lang="fr-FR" sz="1100" dirty="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107T88</a:t>
                      </a:r>
                      <a:endParaRPr lang="fr-FR" sz="1100" dirty="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7.7</a:t>
                      </a:r>
                      <a:endParaRPr lang="fr-FR" sz="1100" dirty="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85.2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73.2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85.3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137T29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54.9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51.5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44.2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81.2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143T493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4.6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8.9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70.9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9.0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153T45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71.2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4.4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70.6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80.7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175T285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55.0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57.6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4.6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6.5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209T622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53.8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5.1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5.4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71.7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210T88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70.9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86.9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77.4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84.7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235T286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58.8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1.0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70.4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7.7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237T437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49.9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76.7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67.5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77.7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321T436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57.6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84.2</a:t>
                      </a:r>
                      <a:endParaRPr lang="fr-FR" sz="1100" dirty="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70.9</a:t>
                      </a:r>
                      <a:endParaRPr lang="fr-FR" sz="110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85.1</a:t>
                      </a:r>
                      <a:endParaRPr lang="fr-FR" sz="1100" dirty="0"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3601" marR="5360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138</Words>
  <Application>Microsoft Office PowerPoint</Application>
  <PresentationFormat>Affichage à l'écran (4:3)</PresentationFormat>
  <Paragraphs>6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Gaelle</dc:creator>
  <cp:lastModifiedBy>GRISON Stephane</cp:lastModifiedBy>
  <cp:revision>18</cp:revision>
  <dcterms:created xsi:type="dcterms:W3CDTF">2014-02-12T09:38:18Z</dcterms:created>
  <dcterms:modified xsi:type="dcterms:W3CDTF">2016-07-20T16:09:02Z</dcterms:modified>
</cp:coreProperties>
</file>